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48" r:id="rId2"/>
    <p:sldId id="349" r:id="rId3"/>
    <p:sldId id="350" r:id="rId4"/>
    <p:sldId id="276" r:id="rId5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信 草場" initials="信" lastIdx="3" clrIdx="0">
    <p:extLst>
      <p:ext uri="{19B8F6BF-5375-455C-9EA6-DF929625EA0E}">
        <p15:presenceInfo xmlns:p15="http://schemas.microsoft.com/office/powerpoint/2012/main" userId="654d778173b47f67" providerId="Windows Live"/>
      </p:ext>
    </p:extLst>
  </p:cmAuthor>
  <p:cmAuthor id="2" name="Makoto Kusaba" initials="MK" lastIdx="1" clrIdx="1">
    <p:extLst>
      <p:ext uri="{19B8F6BF-5375-455C-9EA6-DF929625EA0E}">
        <p15:presenceInfo xmlns:p15="http://schemas.microsoft.com/office/powerpoint/2012/main" userId="Makoto Kusab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DD7EE"/>
    <a:srgbClr val="FFD966"/>
    <a:srgbClr val="F4B183"/>
    <a:srgbClr val="009999"/>
    <a:srgbClr val="BF2F8F"/>
    <a:srgbClr val="8D236A"/>
    <a:srgbClr val="CC3399"/>
    <a:srgbClr val="CC0099"/>
    <a:srgbClr val="FBE5D6"/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67" autoAdjust="0"/>
    <p:restoredTop sz="94660"/>
  </p:normalViewPr>
  <p:slideViewPr>
    <p:cSldViewPr snapToGrid="0">
      <p:cViewPr varScale="1">
        <p:scale>
          <a:sx n="71" d="100"/>
          <a:sy n="71" d="100"/>
        </p:scale>
        <p:origin x="62" y="1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\2024%20&#12466;&#12494;&#12512;&#32232;&#38598;\2024.7&#26376;CIV3&#35542;&#25991;&#29992;_&#12508;&#12523;&#12486;&#12451;&#12531;&#12464;&#26085;&#25968;&#12392;&#36986;&#20253;&#23376;&#22411;&#65286;&#31252;&#23455;&#29575;%20(ANOVA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\2024%20Inversion%20&#12466;&#12494;&#12512;&#32232;&#38598;\&#12466;&#12494;&#12512;&#12487;&#12540;&#12479;\2024.7&#26376;CIV3&#35542;&#25991;&#29992;_&#12508;&#12523;&#12486;&#12451;&#12531;&#12464;&#26085;&#25968;&#12392;&#36986;&#20253;&#23376;&#22411;&#65286;&#31252;&#23455;&#29575;%20(ANOVA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稔実率!$K$24:$M$24</c:f>
                <c:numCache>
                  <c:formatCode>General</c:formatCode>
                  <c:ptCount val="3"/>
                  <c:pt idx="0">
                    <c:v>3.7419739109192101</c:v>
                  </c:pt>
                  <c:pt idx="1">
                    <c:v>2.2971871386545764</c:v>
                  </c:pt>
                  <c:pt idx="2">
                    <c:v>1.03302952523148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稔実率!$K$17:$M$17</c:f>
              <c:strCache>
                <c:ptCount val="3"/>
                <c:pt idx="0">
                  <c:v>Wild-type </c:v>
                </c:pt>
                <c:pt idx="1">
                  <c:v>Inversion hetero</c:v>
                </c:pt>
                <c:pt idx="2">
                  <c:v>Inversion homo</c:v>
                </c:pt>
              </c:strCache>
            </c:strRef>
          </c:cat>
          <c:val>
            <c:numRef>
              <c:f>稔実率!$K$22:$M$22</c:f>
              <c:numCache>
                <c:formatCode>0.00</c:formatCode>
                <c:ptCount val="3"/>
                <c:pt idx="0">
                  <c:v>97.247500000000002</c:v>
                </c:pt>
                <c:pt idx="1">
                  <c:v>97.477499999999992</c:v>
                </c:pt>
                <c:pt idx="2">
                  <c:v>98.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BFB-4BE3-8A7D-B34D69B25C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13972096"/>
        <c:axId val="513969184"/>
      </c:barChart>
      <c:catAx>
        <c:axId val="513972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513969184"/>
        <c:crosses val="autoZero"/>
        <c:auto val="1"/>
        <c:lblAlgn val="ctr"/>
        <c:lblOffset val="100"/>
        <c:noMultiLvlLbl val="0"/>
      </c:catAx>
      <c:valAx>
        <c:axId val="513969184"/>
        <c:scaling>
          <c:orientation val="minMax"/>
          <c:max val="105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ertility  (%)</a:t>
                </a:r>
                <a:endParaRPr lang="ja-JP" altLang="en-US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ja-JP"/>
          </a:p>
        </c:txPr>
        <c:crossAx val="513972096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83082670289153"/>
          <c:y val="3.4756853310002923E-2"/>
          <c:w val="0.77937749108062515"/>
          <c:h val="0.89814814814814814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>
                  <a:lumMod val="40000"/>
                  <a:lumOff val="60000"/>
                </a:schemeClr>
              </a:solidFill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稔実率!$O$19:$O$30</c:f>
              <c:numCache>
                <c:formatCode>General</c:formatCode>
                <c:ptCount val="12"/>
                <c:pt idx="0">
                  <c:v>1</c:v>
                </c:pt>
                <c:pt idx="1">
                  <c:v>1.05</c:v>
                </c:pt>
                <c:pt idx="2">
                  <c:v>1</c:v>
                </c:pt>
                <c:pt idx="3">
                  <c:v>0.95</c:v>
                </c:pt>
                <c:pt idx="4">
                  <c:v>2</c:v>
                </c:pt>
                <c:pt idx="5">
                  <c:v>2.0499999999999998</c:v>
                </c:pt>
                <c:pt idx="6">
                  <c:v>2</c:v>
                </c:pt>
                <c:pt idx="7">
                  <c:v>1.95</c:v>
                </c:pt>
                <c:pt idx="8">
                  <c:v>3.05</c:v>
                </c:pt>
                <c:pt idx="9">
                  <c:v>3</c:v>
                </c:pt>
                <c:pt idx="10">
                  <c:v>3</c:v>
                </c:pt>
                <c:pt idx="11">
                  <c:v>2.95</c:v>
                </c:pt>
              </c:numCache>
            </c:numRef>
          </c:xVal>
          <c:yVal>
            <c:numRef>
              <c:f>稔実率!$P$19:$P$30</c:f>
              <c:numCache>
                <c:formatCode>General</c:formatCode>
                <c:ptCount val="12"/>
                <c:pt idx="0">
                  <c:v>0.90909090909090906</c:v>
                </c:pt>
                <c:pt idx="1">
                  <c:v>1</c:v>
                </c:pt>
                <c:pt idx="2">
                  <c:v>0.98076923076923073</c:v>
                </c:pt>
                <c:pt idx="3">
                  <c:v>1</c:v>
                </c:pt>
                <c:pt idx="4">
                  <c:v>1</c:v>
                </c:pt>
                <c:pt idx="5">
                  <c:v>0.98333333333333328</c:v>
                </c:pt>
                <c:pt idx="6">
                  <c:v>0.9375</c:v>
                </c:pt>
                <c:pt idx="7">
                  <c:v>0.97826086956521741</c:v>
                </c:pt>
                <c:pt idx="8">
                  <c:v>0.98148148148148151</c:v>
                </c:pt>
                <c:pt idx="9">
                  <c:v>1</c:v>
                </c:pt>
                <c:pt idx="10">
                  <c:v>0.971830985915493</c:v>
                </c:pt>
                <c:pt idx="11">
                  <c:v>0.989130434782608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56E-48DE-A0CD-FE29196B1F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1694832"/>
        <c:axId val="1701696080"/>
      </c:scatterChart>
      <c:valAx>
        <c:axId val="17016948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701696080"/>
        <c:crosses val="autoZero"/>
        <c:crossBetween val="midCat"/>
      </c:valAx>
      <c:valAx>
        <c:axId val="1701696080"/>
        <c:scaling>
          <c:orientation val="minMax"/>
          <c:max val="1.2"/>
        </c:scaling>
        <c:delete val="1"/>
        <c:axPos val="l"/>
        <c:numFmt formatCode="General" sourceLinked="1"/>
        <c:majorTickMark val="none"/>
        <c:minorTickMark val="none"/>
        <c:tickLblPos val="nextTo"/>
        <c:crossAx val="17016948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5243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532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240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901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443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952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033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2328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016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702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358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D64783-B8A7-4184-AECD-45397325E795}" type="datetimeFigureOut">
              <a:rPr kumimoji="1" lang="ja-JP" altLang="en-US" smtClean="0"/>
              <a:t>2025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9BC566-CD7E-4273-B6E7-F622C50D22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5365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388E9500-B1E5-4904-9152-D333AC54436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1282818" y="1747779"/>
            <a:ext cx="3886011" cy="1207937"/>
          </a:xfrm>
          <a:prstGeom prst="rect">
            <a:avLst/>
          </a:prstGeom>
        </p:spPr>
      </p:pic>
      <p:cxnSp>
        <p:nvCxnSpPr>
          <p:cNvPr id="4" name="直線矢印コネクタ 3">
            <a:extLst>
              <a:ext uri="{FF2B5EF4-FFF2-40B4-BE49-F238E27FC236}">
                <a16:creationId xmlns:a16="http://schemas.microsoft.com/office/drawing/2014/main" id="{AC1C2B11-73CA-46E4-A0AE-3579301C7979}"/>
              </a:ext>
            </a:extLst>
          </p:cNvPr>
          <p:cNvCxnSpPr>
            <a:cxnSpLocks/>
          </p:cNvCxnSpPr>
          <p:nvPr/>
        </p:nvCxnSpPr>
        <p:spPr>
          <a:xfrm flipH="1" flipV="1">
            <a:off x="4649788" y="2704001"/>
            <a:ext cx="112314" cy="86406"/>
          </a:xfrm>
          <a:prstGeom prst="straightConnector1">
            <a:avLst/>
          </a:prstGeom>
          <a:ln w="25400">
            <a:solidFill>
              <a:schemeClr val="bg1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4D70CB9-EF4A-44E1-BEAB-F20950CF2F43}"/>
              </a:ext>
            </a:extLst>
          </p:cNvPr>
          <p:cNvSpPr txBox="1"/>
          <p:nvPr/>
        </p:nvSpPr>
        <p:spPr>
          <a:xfrm>
            <a:off x="223250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DF33E5E-5FCA-45E6-A8F3-189C3F4FA243}"/>
              </a:ext>
            </a:extLst>
          </p:cNvPr>
          <p:cNvSpPr txBox="1"/>
          <p:nvPr/>
        </p:nvSpPr>
        <p:spPr>
          <a:xfrm>
            <a:off x="4613059" y="2944975"/>
            <a:ext cx="387827" cy="334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F887B43-F90D-4C2D-A80C-0B999A59D994}"/>
              </a:ext>
            </a:extLst>
          </p:cNvPr>
          <p:cNvSpPr txBox="1"/>
          <p:nvPr/>
        </p:nvSpPr>
        <p:spPr>
          <a:xfrm>
            <a:off x="3109604" y="2944975"/>
            <a:ext cx="387827" cy="334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4A76CC5-9122-4207-8982-08A8CE368251}"/>
              </a:ext>
            </a:extLst>
          </p:cNvPr>
          <p:cNvSpPr txBox="1"/>
          <p:nvPr/>
        </p:nvSpPr>
        <p:spPr>
          <a:xfrm>
            <a:off x="3313144" y="2944975"/>
            <a:ext cx="387827" cy="334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93523D5-3EB4-44C5-973A-8CA4BF98C466}"/>
              </a:ext>
            </a:extLst>
          </p:cNvPr>
          <p:cNvSpPr txBox="1"/>
          <p:nvPr/>
        </p:nvSpPr>
        <p:spPr>
          <a:xfrm>
            <a:off x="4816595" y="2944975"/>
            <a:ext cx="387827" cy="334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1CF0A13-7133-4FA1-90DB-CD9BD71629AB}"/>
              </a:ext>
            </a:extLst>
          </p:cNvPr>
          <p:cNvSpPr txBox="1"/>
          <p:nvPr/>
        </p:nvSpPr>
        <p:spPr>
          <a:xfrm>
            <a:off x="2013229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D16F043-426E-4878-9C99-85D8566E6A8E}"/>
              </a:ext>
            </a:extLst>
          </p:cNvPr>
          <p:cNvSpPr txBox="1"/>
          <p:nvPr/>
        </p:nvSpPr>
        <p:spPr>
          <a:xfrm>
            <a:off x="2451779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138AE35-6D3D-4235-99E8-E7E34B000BB9}"/>
              </a:ext>
            </a:extLst>
          </p:cNvPr>
          <p:cNvSpPr txBox="1"/>
          <p:nvPr/>
        </p:nvSpPr>
        <p:spPr>
          <a:xfrm>
            <a:off x="267105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F148ADB-C7EE-4ACD-A371-B0DF2CA6B299}"/>
              </a:ext>
            </a:extLst>
          </p:cNvPr>
          <p:cNvSpPr txBox="1"/>
          <p:nvPr/>
        </p:nvSpPr>
        <p:spPr>
          <a:xfrm>
            <a:off x="2890329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CC5318B-F6E1-46ED-B099-99E19929C41B}"/>
              </a:ext>
            </a:extLst>
          </p:cNvPr>
          <p:cNvSpPr txBox="1"/>
          <p:nvPr/>
        </p:nvSpPr>
        <p:spPr>
          <a:xfrm>
            <a:off x="351668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09BDBA9-FD7F-4873-96B3-ADEBD41D16B7}"/>
              </a:ext>
            </a:extLst>
          </p:cNvPr>
          <p:cNvSpPr txBox="1"/>
          <p:nvPr/>
        </p:nvSpPr>
        <p:spPr>
          <a:xfrm>
            <a:off x="3735959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3407053-FC51-4AA8-93F8-29E694A148EE}"/>
              </a:ext>
            </a:extLst>
          </p:cNvPr>
          <p:cNvSpPr txBox="1"/>
          <p:nvPr/>
        </p:nvSpPr>
        <p:spPr>
          <a:xfrm>
            <a:off x="395523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F1939A1-A73A-472F-8258-627775890FDC}"/>
              </a:ext>
            </a:extLst>
          </p:cNvPr>
          <p:cNvSpPr txBox="1"/>
          <p:nvPr/>
        </p:nvSpPr>
        <p:spPr>
          <a:xfrm>
            <a:off x="4174509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2F03946-16CC-494B-9BC4-9FB10F4E199D}"/>
              </a:ext>
            </a:extLst>
          </p:cNvPr>
          <p:cNvSpPr txBox="1"/>
          <p:nvPr/>
        </p:nvSpPr>
        <p:spPr>
          <a:xfrm>
            <a:off x="439378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3C8EDB95-9886-4A88-808F-CFBD0A9E1E1D}"/>
              </a:ext>
            </a:extLst>
          </p:cNvPr>
          <p:cNvGrpSpPr/>
          <p:nvPr/>
        </p:nvGrpSpPr>
        <p:grpSpPr>
          <a:xfrm>
            <a:off x="1798574" y="2197753"/>
            <a:ext cx="2934224" cy="369482"/>
            <a:chOff x="2020944" y="2474866"/>
            <a:chExt cx="2934224" cy="369482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1A97719-D33C-45B6-B228-9D5566545BEB}"/>
                </a:ext>
              </a:extLst>
            </p:cNvPr>
            <p:cNvSpPr txBox="1"/>
            <p:nvPr/>
          </p:nvSpPr>
          <p:spPr>
            <a:xfrm>
              <a:off x="2233133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08919D3C-F6A9-437D-B528-0D3CCC6CD1A5}"/>
                </a:ext>
              </a:extLst>
            </p:cNvPr>
            <p:cNvSpPr txBox="1"/>
            <p:nvPr/>
          </p:nvSpPr>
          <p:spPr>
            <a:xfrm>
              <a:off x="2449203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6CDAD33C-1A27-453B-8EF4-FF4BF2829DEB}"/>
                </a:ext>
              </a:extLst>
            </p:cNvPr>
            <p:cNvSpPr txBox="1"/>
            <p:nvPr/>
          </p:nvSpPr>
          <p:spPr>
            <a:xfrm>
              <a:off x="2671607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C326B22F-E9E2-4D8A-9EDA-B1CB35F40D86}"/>
                </a:ext>
              </a:extLst>
            </p:cNvPr>
            <p:cNvSpPr txBox="1"/>
            <p:nvPr/>
          </p:nvSpPr>
          <p:spPr>
            <a:xfrm>
              <a:off x="2890382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D45D957F-5882-46E7-885E-E189C5DC74D2}"/>
                </a:ext>
              </a:extLst>
            </p:cNvPr>
            <p:cNvSpPr txBox="1"/>
            <p:nvPr/>
          </p:nvSpPr>
          <p:spPr>
            <a:xfrm>
              <a:off x="3114584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0DA99DE6-725F-45F9-B709-D12416C69075}"/>
                </a:ext>
              </a:extLst>
            </p:cNvPr>
            <p:cNvSpPr txBox="1"/>
            <p:nvPr/>
          </p:nvSpPr>
          <p:spPr>
            <a:xfrm>
              <a:off x="3752200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874D63BF-CB61-49AF-BF01-C8CC94DC9AA5}"/>
                </a:ext>
              </a:extLst>
            </p:cNvPr>
            <p:cNvSpPr txBox="1"/>
            <p:nvPr/>
          </p:nvSpPr>
          <p:spPr>
            <a:xfrm>
              <a:off x="3955449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BC6218D1-EC91-4444-AC7E-0862C441A5F5}"/>
                </a:ext>
              </a:extLst>
            </p:cNvPr>
            <p:cNvSpPr txBox="1"/>
            <p:nvPr/>
          </p:nvSpPr>
          <p:spPr>
            <a:xfrm>
              <a:off x="4185996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E4C3122-169C-4334-BC43-94AC09BBD619}"/>
                </a:ext>
              </a:extLst>
            </p:cNvPr>
            <p:cNvSpPr txBox="1"/>
            <p:nvPr/>
          </p:nvSpPr>
          <p:spPr>
            <a:xfrm>
              <a:off x="4397814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F3BE0E79-D247-4317-BB0D-EECEFAC15CC9}"/>
                </a:ext>
              </a:extLst>
            </p:cNvPr>
            <p:cNvSpPr txBox="1"/>
            <p:nvPr/>
          </p:nvSpPr>
          <p:spPr>
            <a:xfrm>
              <a:off x="4630808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242C82CE-CAAF-4720-83C9-C717349DF1A0}"/>
                </a:ext>
              </a:extLst>
            </p:cNvPr>
            <p:cNvSpPr txBox="1"/>
            <p:nvPr/>
          </p:nvSpPr>
          <p:spPr>
            <a:xfrm>
              <a:off x="2020944" y="2474866"/>
              <a:ext cx="324360" cy="3694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bg1"/>
                  </a:solidFill>
                </a:rPr>
                <a:t>*</a:t>
              </a:r>
              <a:endParaRPr kumimoji="1" lang="ja-JP" altLang="en-US" sz="1200" dirty="0">
                <a:solidFill>
                  <a:schemeClr val="bg1"/>
                </a:solidFill>
              </a:endParaRPr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4C83B42-C984-4C94-A47E-75C5DD6C9AFD}"/>
              </a:ext>
            </a:extLst>
          </p:cNvPr>
          <p:cNvSpPr txBox="1"/>
          <p:nvPr/>
        </p:nvSpPr>
        <p:spPr>
          <a:xfrm>
            <a:off x="3190806" y="1729810"/>
            <a:ext cx="336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2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baseline="-25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C309651-C184-4966-A8B7-5F044B7D8826}"/>
              </a:ext>
            </a:extLst>
          </p:cNvPr>
          <p:cNvSpPr txBox="1"/>
          <p:nvPr/>
        </p:nvSpPr>
        <p:spPr>
          <a:xfrm rot="16200000">
            <a:off x="1500726" y="1841508"/>
            <a:ext cx="413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l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DD5E4C9B-976E-4409-9A15-927A09227350}"/>
              </a:ext>
            </a:extLst>
          </p:cNvPr>
          <p:cNvSpPr txBox="1"/>
          <p:nvPr/>
        </p:nvSpPr>
        <p:spPr>
          <a:xfrm rot="16200000">
            <a:off x="1697112" y="1800523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kumimoji="1" lang="en-US" altLang="ja-JP" sz="1200" baseline="-25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ja-JP" altLang="en-US" sz="1200" dirty="0">
                <a:solidFill>
                  <a:schemeClr val="bg1"/>
                </a:solidFill>
              </a:rPr>
              <a:t>①</a:t>
            </a:r>
          </a:p>
        </p:txBody>
      </p: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6F0F7F79-29C9-43DE-AFB3-1555705BF0A7}"/>
              </a:ext>
            </a:extLst>
          </p:cNvPr>
          <p:cNvCxnSpPr>
            <a:cxnSpLocks/>
          </p:cNvCxnSpPr>
          <p:nvPr/>
        </p:nvCxnSpPr>
        <p:spPr>
          <a:xfrm>
            <a:off x="2100140" y="2028017"/>
            <a:ext cx="2926247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>
            <a:extLst>
              <a:ext uri="{FF2B5EF4-FFF2-40B4-BE49-F238E27FC236}">
                <a16:creationId xmlns:a16="http://schemas.microsoft.com/office/drawing/2014/main" id="{75FABF81-30CA-4A44-905F-7604BEAD90AD}"/>
              </a:ext>
            </a:extLst>
          </p:cNvPr>
          <p:cNvCxnSpPr>
            <a:cxnSpLocks/>
          </p:cNvCxnSpPr>
          <p:nvPr/>
        </p:nvCxnSpPr>
        <p:spPr>
          <a:xfrm rot="900000" flipH="1">
            <a:off x="4653083" y="2454812"/>
            <a:ext cx="89270" cy="111510"/>
          </a:xfrm>
          <a:prstGeom prst="straightConnector1">
            <a:avLst/>
          </a:prstGeom>
          <a:ln w="25400">
            <a:solidFill>
              <a:srgbClr val="FFC000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854D17F-6C0E-4276-B523-9A29E271CC0A}"/>
              </a:ext>
            </a:extLst>
          </p:cNvPr>
          <p:cNvSpPr txBox="1"/>
          <p:nvPr/>
        </p:nvSpPr>
        <p:spPr>
          <a:xfrm>
            <a:off x="1793954" y="2944975"/>
            <a:ext cx="321003" cy="2832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BAB7112-9BC7-4751-BD3C-56D07BFC6E4C}"/>
              </a:ext>
            </a:extLst>
          </p:cNvPr>
          <p:cNvSpPr txBox="1"/>
          <p:nvPr/>
        </p:nvSpPr>
        <p:spPr>
          <a:xfrm>
            <a:off x="1590413" y="2944975"/>
            <a:ext cx="387827" cy="3340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9E01889-6669-4CD7-8FD8-6C4F0C834E00}"/>
              </a:ext>
            </a:extLst>
          </p:cNvPr>
          <p:cNvSpPr txBox="1"/>
          <p:nvPr/>
        </p:nvSpPr>
        <p:spPr>
          <a:xfrm>
            <a:off x="733720" y="1280553"/>
            <a:ext cx="221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1243DC6-88CD-4EF9-98BF-E58924D52B6B}"/>
              </a:ext>
            </a:extLst>
          </p:cNvPr>
          <p:cNvSpPr txBox="1"/>
          <p:nvPr/>
        </p:nvSpPr>
        <p:spPr>
          <a:xfrm>
            <a:off x="318698" y="7169500"/>
            <a:ext cx="635997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1. Early flowering in plants harboring a genomic fragment containing an 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TA3-FT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usion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(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. Multiplex genotyping PCR; White and yellow arrowheads indicate the wild-type band and the band expected for the inversion, respectively; * indicates an inversion-positive sample. Flowering time was recorded for the T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dividuals derived from the inversion-positive T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dividual under short-day conditions. E, early flowering; N, normally flowering. (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) Representative photograph showing the flowering phenotype of 28-day-old T</a:t>
            </a:r>
            <a:r>
              <a:rPr lang="en-US" altLang="ja-JP" sz="1200" kern="100" baseline="-250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ransgenic plants harboring an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TA3-FT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enomic fragment grown under short-day conditions. For comparison,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one plant from the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genome-edited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HTA3-F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version line is shown. The vector control is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 transformant harboring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CaMV35S:Venus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18BC6C5-FFDB-491E-8FF6-39EE3595CC44}"/>
              </a:ext>
            </a:extLst>
          </p:cNvPr>
          <p:cNvSpPr txBox="1"/>
          <p:nvPr/>
        </p:nvSpPr>
        <p:spPr>
          <a:xfrm rot="19140174">
            <a:off x="1849265" y="6226275"/>
            <a:ext cx="10534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Vector control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309C820-BB91-44C0-B26A-B3D36985AE66}"/>
              </a:ext>
            </a:extLst>
          </p:cNvPr>
          <p:cNvSpPr txBox="1"/>
          <p:nvPr/>
        </p:nvSpPr>
        <p:spPr>
          <a:xfrm rot="19140174">
            <a:off x="1259776" y="6174987"/>
            <a:ext cx="78899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HTA3-FT</a:t>
            </a:r>
            <a:endParaRPr kumimoji="1" lang="en-US" altLang="ja-JP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nversio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8FF1986-D098-4906-B478-8794E46A57A5}"/>
              </a:ext>
            </a:extLst>
          </p:cNvPr>
          <p:cNvSpPr txBox="1"/>
          <p:nvPr/>
        </p:nvSpPr>
        <p:spPr>
          <a:xfrm rot="19140174">
            <a:off x="2734508" y="6161875"/>
            <a:ext cx="8899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HTA3-FT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enome #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538215C-4F55-454E-9FA3-BFF811D1F74D}"/>
              </a:ext>
            </a:extLst>
          </p:cNvPr>
          <p:cNvSpPr txBox="1"/>
          <p:nvPr/>
        </p:nvSpPr>
        <p:spPr>
          <a:xfrm rot="19140174">
            <a:off x="3471474" y="6161875"/>
            <a:ext cx="8899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HTA3-FT </a:t>
            </a:r>
          </a:p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enome #2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図 44">
            <a:extLst>
              <a:ext uri="{FF2B5EF4-FFF2-40B4-BE49-F238E27FC236}">
                <a16:creationId xmlns:a16="http://schemas.microsoft.com/office/drawing/2014/main" id="{1714D45B-5688-49B6-93A9-F3F111B4D79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82818" y="3753404"/>
            <a:ext cx="3962099" cy="2143593"/>
          </a:xfrm>
          <a:prstGeom prst="rect">
            <a:avLst/>
          </a:prstGeom>
        </p:spPr>
      </p:pic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359814B-322F-4402-8F33-6E6B8B6DA205}"/>
              </a:ext>
            </a:extLst>
          </p:cNvPr>
          <p:cNvSpPr txBox="1"/>
          <p:nvPr/>
        </p:nvSpPr>
        <p:spPr>
          <a:xfrm rot="19140174">
            <a:off x="4208440" y="6161875"/>
            <a:ext cx="88998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HTA3-FT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r"/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genome #3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EF053FAD-3C94-401B-9321-1CC000DE173E}"/>
              </a:ext>
            </a:extLst>
          </p:cNvPr>
          <p:cNvCxnSpPr/>
          <p:nvPr/>
        </p:nvCxnSpPr>
        <p:spPr>
          <a:xfrm>
            <a:off x="3074472" y="5988501"/>
            <a:ext cx="2067648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B12951A3-FD25-405E-8C66-E6753BAEC5C0}"/>
              </a:ext>
            </a:extLst>
          </p:cNvPr>
          <p:cNvSpPr txBox="1"/>
          <p:nvPr/>
        </p:nvSpPr>
        <p:spPr>
          <a:xfrm>
            <a:off x="733720" y="3568738"/>
            <a:ext cx="2218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6809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B400AB04-7A85-48FE-971E-80E929329E7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2801947" y="3043560"/>
            <a:ext cx="1104547" cy="1644637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88C1644-8356-43D9-871C-C777BD56E622}"/>
              </a:ext>
            </a:extLst>
          </p:cNvPr>
          <p:cNvSpPr txBox="1"/>
          <p:nvPr/>
        </p:nvSpPr>
        <p:spPr>
          <a:xfrm>
            <a:off x="249010" y="5532482"/>
            <a:ext cx="635997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2. 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T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expression in the 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HTA3-FT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version plants. 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Diagram showing th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mRNA and the positions of primers used for RT-PCR.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, RT-PCR products for th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ranscript generated using primers designed to anneal to the 5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  <a:sym typeface="Symbol" panose="05050102010706020507" pitchFamily="18" charset="2"/>
              </a:rPr>
              <a:t>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UTR and 3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  <a:sym typeface="Symbol" panose="05050102010706020507" pitchFamily="18" charset="2"/>
              </a:rPr>
              <a:t>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UTR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. The arrowhead corresponds to the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T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transcript encompassing the complete coding sequence, which was verified through Sanger sequencing. Total RNA was extracted from 16-day-old Col-0 seedlings grown under long-day conditions and 9-day-old seedlings of the inversion line grown under short-day conditions.  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53EBF81-9B0E-475A-926C-A3C419B52E27}"/>
              </a:ext>
            </a:extLst>
          </p:cNvPr>
          <p:cNvSpPr txBox="1"/>
          <p:nvPr/>
        </p:nvSpPr>
        <p:spPr>
          <a:xfrm>
            <a:off x="2005951" y="1971655"/>
            <a:ext cx="421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kumimoji="1" lang="ja-JP" altLang="en-US" sz="1400" i="1" dirty="0">
              <a:solidFill>
                <a:schemeClr val="accent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4EBE971A-317C-45E5-B151-0BC3FF0F788B}"/>
              </a:ext>
            </a:extLst>
          </p:cNvPr>
          <p:cNvSpPr/>
          <p:nvPr/>
        </p:nvSpPr>
        <p:spPr>
          <a:xfrm>
            <a:off x="2743661" y="2125544"/>
            <a:ext cx="153104" cy="5103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CC3BE021-624B-46D7-AAE3-C0317AB90E66}"/>
              </a:ext>
            </a:extLst>
          </p:cNvPr>
          <p:cNvSpPr/>
          <p:nvPr/>
        </p:nvSpPr>
        <p:spPr>
          <a:xfrm>
            <a:off x="3867821" y="2125544"/>
            <a:ext cx="459311" cy="5103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A3BA49A9-2D59-4180-AC9C-DA683416664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727994" y="1969872"/>
            <a:ext cx="147707" cy="4571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36CC493-D0D2-481A-82FD-6D970C9497C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950685" y="1975647"/>
            <a:ext cx="133892" cy="45719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36ECD55-B352-4146-88BB-3380A7D09887}"/>
              </a:ext>
            </a:extLst>
          </p:cNvPr>
          <p:cNvSpPr txBox="1"/>
          <p:nvPr/>
        </p:nvSpPr>
        <p:spPr>
          <a:xfrm>
            <a:off x="2515028" y="1722034"/>
            <a:ext cx="526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FT-F2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6F76C51-967A-47CE-9C20-3B08C71B264E}"/>
              </a:ext>
            </a:extLst>
          </p:cNvPr>
          <p:cNvSpPr txBox="1"/>
          <p:nvPr/>
        </p:nvSpPr>
        <p:spPr>
          <a:xfrm>
            <a:off x="3821931" y="1730625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chemeClr val="accent1">
                    <a:lumMod val="75000"/>
                  </a:schemeClr>
                </a:solidFill>
              </a:rPr>
              <a:t>FT-R2</a:t>
            </a:r>
            <a:endParaRPr kumimoji="1" lang="ja-JP" altLang="en-US" sz="12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E81BCD6-CD1B-4E21-81E3-273531129842}"/>
              </a:ext>
            </a:extLst>
          </p:cNvPr>
          <p:cNvSpPr txBox="1"/>
          <p:nvPr/>
        </p:nvSpPr>
        <p:spPr>
          <a:xfrm>
            <a:off x="2671786" y="2297399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ATG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495FB51C-E84A-4D55-8BE3-92054E15E5D7}"/>
              </a:ext>
            </a:extLst>
          </p:cNvPr>
          <p:cNvCxnSpPr>
            <a:cxnSpLocks/>
            <a:stCxn id="11" idx="0"/>
            <a:endCxn id="11" idx="0"/>
          </p:cNvCxnSpPr>
          <p:nvPr/>
        </p:nvCxnSpPr>
        <p:spPr>
          <a:xfrm>
            <a:off x="2882741" y="2297399"/>
            <a:ext cx="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A72ABCE-1937-47E4-AE73-8D9AE6093D55}"/>
              </a:ext>
            </a:extLst>
          </p:cNvPr>
          <p:cNvSpPr txBox="1"/>
          <p:nvPr/>
        </p:nvSpPr>
        <p:spPr>
          <a:xfrm>
            <a:off x="3669486" y="2297399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TAG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41646BF8-96BD-42B7-B3B4-C3E04F7AD0A2}"/>
              </a:ext>
            </a:extLst>
          </p:cNvPr>
          <p:cNvCxnSpPr>
            <a:cxnSpLocks/>
            <a:stCxn id="19" idx="1"/>
            <a:endCxn id="11" idx="0"/>
          </p:cNvCxnSpPr>
          <p:nvPr/>
        </p:nvCxnSpPr>
        <p:spPr>
          <a:xfrm>
            <a:off x="2882741" y="2151062"/>
            <a:ext cx="0" cy="1463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0D2B812B-4F11-4238-8721-DD25ECE2C2EC}"/>
              </a:ext>
            </a:extLst>
          </p:cNvPr>
          <p:cNvCxnSpPr>
            <a:cxnSpLocks/>
          </p:cNvCxnSpPr>
          <p:nvPr/>
        </p:nvCxnSpPr>
        <p:spPr>
          <a:xfrm>
            <a:off x="3864443" y="2151062"/>
            <a:ext cx="0" cy="14633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4B4BFB49-4DD9-4DC9-B9FA-21C2F16153FC}"/>
              </a:ext>
            </a:extLst>
          </p:cNvPr>
          <p:cNvSpPr/>
          <p:nvPr/>
        </p:nvSpPr>
        <p:spPr>
          <a:xfrm>
            <a:off x="3446249" y="2092477"/>
            <a:ext cx="421035" cy="117169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444ED4E2-8467-49A0-BABC-99CC335A304F}"/>
              </a:ext>
            </a:extLst>
          </p:cNvPr>
          <p:cNvSpPr/>
          <p:nvPr/>
        </p:nvSpPr>
        <p:spPr>
          <a:xfrm>
            <a:off x="3376603" y="2092477"/>
            <a:ext cx="76552" cy="11716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18CD218-8A8E-44F4-980E-AE9CC799C488}"/>
              </a:ext>
            </a:extLst>
          </p:cNvPr>
          <p:cNvSpPr/>
          <p:nvPr/>
        </p:nvSpPr>
        <p:spPr>
          <a:xfrm>
            <a:off x="3264004" y="2092477"/>
            <a:ext cx="114828" cy="117169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DA3E1191-A4B8-492A-9F1C-5FD160505636}"/>
              </a:ext>
            </a:extLst>
          </p:cNvPr>
          <p:cNvSpPr/>
          <p:nvPr/>
        </p:nvSpPr>
        <p:spPr>
          <a:xfrm>
            <a:off x="2882741" y="2092477"/>
            <a:ext cx="382759" cy="117169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A95AF44-98E4-479A-8A8C-76D25FFA5D08}"/>
              </a:ext>
            </a:extLst>
          </p:cNvPr>
          <p:cNvSpPr txBox="1"/>
          <p:nvPr/>
        </p:nvSpPr>
        <p:spPr>
          <a:xfrm>
            <a:off x="1559555" y="1516147"/>
            <a:ext cx="265340" cy="313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EBC3D68-E171-4168-8F53-14CFCB831097}"/>
              </a:ext>
            </a:extLst>
          </p:cNvPr>
          <p:cNvSpPr txBox="1"/>
          <p:nvPr/>
        </p:nvSpPr>
        <p:spPr>
          <a:xfrm>
            <a:off x="1554118" y="2674230"/>
            <a:ext cx="2762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A33F98B-28A3-43EC-800F-6F9839463BC3}"/>
              </a:ext>
            </a:extLst>
          </p:cNvPr>
          <p:cNvSpPr txBox="1"/>
          <p:nvPr/>
        </p:nvSpPr>
        <p:spPr>
          <a:xfrm rot="18952681">
            <a:off x="3010249" y="4743566"/>
            <a:ext cx="622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ol-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CD80C6F-A28B-418B-8480-2B3C99D66CFA}"/>
              </a:ext>
            </a:extLst>
          </p:cNvPr>
          <p:cNvSpPr txBox="1"/>
          <p:nvPr/>
        </p:nvSpPr>
        <p:spPr>
          <a:xfrm rot="18903059">
            <a:off x="3153179" y="4857457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nvers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F1EF668-BC68-4BE9-BFFC-9851F916A632}"/>
              </a:ext>
            </a:extLst>
          </p:cNvPr>
          <p:cNvSpPr txBox="1"/>
          <p:nvPr/>
        </p:nvSpPr>
        <p:spPr>
          <a:xfrm>
            <a:off x="2435647" y="384222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00</a:t>
            </a:r>
            <a:endParaRPr kumimoji="1" lang="ja-JP" altLang="en-US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139A5B8-E0C6-43D5-A587-2DC0FB78EDFB}"/>
              </a:ext>
            </a:extLst>
          </p:cNvPr>
          <p:cNvSpPr txBox="1"/>
          <p:nvPr/>
        </p:nvSpPr>
        <p:spPr>
          <a:xfrm>
            <a:off x="2357100" y="3334520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500</a:t>
            </a:r>
            <a:endParaRPr kumimoji="1" lang="ja-JP" altLang="en-US" sz="12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25E7CCD-6EB4-4F67-9061-372119C109BD}"/>
              </a:ext>
            </a:extLst>
          </p:cNvPr>
          <p:cNvSpPr txBox="1"/>
          <p:nvPr/>
        </p:nvSpPr>
        <p:spPr>
          <a:xfrm>
            <a:off x="2357100" y="3529575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000</a:t>
            </a:r>
            <a:endParaRPr kumimoji="1" lang="ja-JP" altLang="en-US" sz="12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A66DD4A-5B36-4B19-9A8B-8B19BDE7E0C6}"/>
              </a:ext>
            </a:extLst>
          </p:cNvPr>
          <p:cNvSpPr txBox="1"/>
          <p:nvPr/>
        </p:nvSpPr>
        <p:spPr>
          <a:xfrm>
            <a:off x="2503555" y="3990103"/>
            <a:ext cx="3449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bp</a:t>
            </a:r>
            <a:endParaRPr kumimoji="1" lang="ja-JP" altLang="en-US" sz="1200" dirty="0"/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CEB27281-9791-420E-A037-2422C95F5CF5}"/>
              </a:ext>
            </a:extLst>
          </p:cNvPr>
          <p:cNvCxnSpPr>
            <a:cxnSpLocks/>
          </p:cNvCxnSpPr>
          <p:nvPr/>
        </p:nvCxnSpPr>
        <p:spPr>
          <a:xfrm flipH="1">
            <a:off x="4128338" y="2654264"/>
            <a:ext cx="18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04B5269-7CE2-4C1C-8118-75E43550D117}"/>
              </a:ext>
            </a:extLst>
          </p:cNvPr>
          <p:cNvSpPr txBox="1"/>
          <p:nvPr/>
        </p:nvSpPr>
        <p:spPr>
          <a:xfrm>
            <a:off x="3949674" y="2641163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100 bp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D4F4A76E-A984-4ADA-B596-502EEA488BD4}"/>
              </a:ext>
            </a:extLst>
          </p:cNvPr>
          <p:cNvCxnSpPr>
            <a:cxnSpLocks/>
          </p:cNvCxnSpPr>
          <p:nvPr/>
        </p:nvCxnSpPr>
        <p:spPr>
          <a:xfrm flipH="1">
            <a:off x="3910275" y="3832499"/>
            <a:ext cx="165370" cy="0"/>
          </a:xfrm>
          <a:prstGeom prst="straightConnector1">
            <a:avLst/>
          </a:prstGeom>
          <a:ln w="38100">
            <a:solidFill>
              <a:srgbClr val="FF0000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942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DB9E94-CACC-4883-BD90-780619423001}"/>
              </a:ext>
            </a:extLst>
          </p:cNvPr>
          <p:cNvSpPr txBox="1"/>
          <p:nvPr/>
        </p:nvSpPr>
        <p:spPr>
          <a:xfrm>
            <a:off x="478131" y="5600151"/>
            <a:ext cx="60807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igure S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3.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Fertility analysis of plants homozygous or heterozygous for the</a:t>
            </a:r>
            <a:r>
              <a:rPr lang="en-US" altLang="ja-JP" sz="1200" b="1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HTA3-FT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 inversion.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Fertility was measured as the percentage of placenta that develop seeds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in developing siliques. ANOVA revealed no significant differences among the three genotypes (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=4).  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F93F8614-8C98-4F71-A6E2-DB634BF84606}"/>
              </a:ext>
            </a:extLst>
          </p:cNvPr>
          <p:cNvGrpSpPr/>
          <p:nvPr/>
        </p:nvGrpSpPr>
        <p:grpSpPr>
          <a:xfrm>
            <a:off x="2025483" y="2310718"/>
            <a:ext cx="2371395" cy="3052833"/>
            <a:chOff x="2060641" y="4650885"/>
            <a:chExt cx="2177142" cy="2743126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5014613A-F64D-4FFD-973F-DF0F8EB834E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12485613"/>
                </p:ext>
              </p:extLst>
            </p:nvPr>
          </p:nvGraphicFramePr>
          <p:xfrm>
            <a:off x="2060641" y="4650885"/>
            <a:ext cx="2177142" cy="27431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6D546AE8-1292-400B-90D8-955882844C3C}"/>
                </a:ext>
              </a:extLst>
            </p:cNvPr>
            <p:cNvGrpSpPr/>
            <p:nvPr/>
          </p:nvGrpSpPr>
          <p:grpSpPr>
            <a:xfrm>
              <a:off x="2875681" y="4845569"/>
              <a:ext cx="67736" cy="64799"/>
              <a:chOff x="5968999" y="1786464"/>
              <a:chExt cx="76200" cy="180000"/>
            </a:xfrm>
          </p:grpSpPr>
          <p:cxnSp>
            <p:nvCxnSpPr>
              <p:cNvPr id="12" name="直線コネクタ 11">
                <a:extLst>
                  <a:ext uri="{FF2B5EF4-FFF2-40B4-BE49-F238E27FC236}">
                    <a16:creationId xmlns:a16="http://schemas.microsoft.com/office/drawing/2014/main" id="{F2BEA186-71E7-4C96-9080-9FD3B4B22FE4}"/>
                  </a:ext>
                </a:extLst>
              </p:cNvPr>
              <p:cNvCxnSpPr/>
              <p:nvPr/>
            </p:nvCxnSpPr>
            <p:spPr>
              <a:xfrm>
                <a:off x="5968999" y="1786467"/>
                <a:ext cx="76200" cy="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>
                <a:extLst>
                  <a:ext uri="{FF2B5EF4-FFF2-40B4-BE49-F238E27FC236}">
                    <a16:creationId xmlns:a16="http://schemas.microsoft.com/office/drawing/2014/main" id="{48B9E8E6-856D-42F0-B953-B0392DCCF1B4}"/>
                  </a:ext>
                </a:extLst>
              </p:cNvPr>
              <p:cNvCxnSpPr/>
              <p:nvPr/>
            </p:nvCxnSpPr>
            <p:spPr>
              <a:xfrm>
                <a:off x="6002780" y="1786464"/>
                <a:ext cx="0" cy="18000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40001375-69B1-48F1-8374-59263A58B3C9}"/>
                </a:ext>
              </a:extLst>
            </p:cNvPr>
            <p:cNvGrpSpPr/>
            <p:nvPr/>
          </p:nvGrpSpPr>
          <p:grpSpPr>
            <a:xfrm>
              <a:off x="3356350" y="4864686"/>
              <a:ext cx="67736" cy="43199"/>
              <a:chOff x="5994933" y="1786467"/>
              <a:chExt cx="76200" cy="180000"/>
            </a:xfrm>
          </p:grpSpPr>
          <p:cxnSp>
            <p:nvCxnSpPr>
              <p:cNvPr id="10" name="直線コネクタ 9">
                <a:extLst>
                  <a:ext uri="{FF2B5EF4-FFF2-40B4-BE49-F238E27FC236}">
                    <a16:creationId xmlns:a16="http://schemas.microsoft.com/office/drawing/2014/main" id="{E0F788CE-DDAD-4CF0-9A21-545BAD958548}"/>
                  </a:ext>
                </a:extLst>
              </p:cNvPr>
              <p:cNvCxnSpPr/>
              <p:nvPr/>
            </p:nvCxnSpPr>
            <p:spPr>
              <a:xfrm>
                <a:off x="5994933" y="1786474"/>
                <a:ext cx="76200" cy="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>
                <a:extLst>
                  <a:ext uri="{FF2B5EF4-FFF2-40B4-BE49-F238E27FC236}">
                    <a16:creationId xmlns:a16="http://schemas.microsoft.com/office/drawing/2014/main" id="{E90B7B76-2E42-4E6D-9448-D43B02ADC48F}"/>
                  </a:ext>
                </a:extLst>
              </p:cNvPr>
              <p:cNvCxnSpPr/>
              <p:nvPr/>
            </p:nvCxnSpPr>
            <p:spPr>
              <a:xfrm>
                <a:off x="6028703" y="1786467"/>
                <a:ext cx="0" cy="18000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8E1ED022-E1FE-4903-8663-1B9CA4BDC137}"/>
                </a:ext>
              </a:extLst>
            </p:cNvPr>
            <p:cNvGrpSpPr/>
            <p:nvPr/>
          </p:nvGrpSpPr>
          <p:grpSpPr>
            <a:xfrm>
              <a:off x="3836515" y="4865293"/>
              <a:ext cx="67735" cy="18000"/>
              <a:chOff x="6020864" y="1754245"/>
              <a:chExt cx="76200" cy="180000"/>
            </a:xfrm>
          </p:grpSpPr>
          <p:cxnSp>
            <p:nvCxnSpPr>
              <p:cNvPr id="8" name="直線コネクタ 7">
                <a:extLst>
                  <a:ext uri="{FF2B5EF4-FFF2-40B4-BE49-F238E27FC236}">
                    <a16:creationId xmlns:a16="http://schemas.microsoft.com/office/drawing/2014/main" id="{D203BAA7-A9E4-445E-9D91-C3E6AD4FF550}"/>
                  </a:ext>
                </a:extLst>
              </p:cNvPr>
              <p:cNvCxnSpPr/>
              <p:nvPr/>
            </p:nvCxnSpPr>
            <p:spPr>
              <a:xfrm>
                <a:off x="6020864" y="1754245"/>
                <a:ext cx="76200" cy="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直線コネクタ 8">
                <a:extLst>
                  <a:ext uri="{FF2B5EF4-FFF2-40B4-BE49-F238E27FC236}">
                    <a16:creationId xmlns:a16="http://schemas.microsoft.com/office/drawing/2014/main" id="{E1D037E8-408B-4840-9719-F2CF843B0754}"/>
                  </a:ext>
                </a:extLst>
              </p:cNvPr>
              <p:cNvCxnSpPr/>
              <p:nvPr/>
            </p:nvCxnSpPr>
            <p:spPr>
              <a:xfrm>
                <a:off x="6054711" y="1754245"/>
                <a:ext cx="0" cy="180000"/>
              </a:xfrm>
              <a:prstGeom prst="line">
                <a:avLst/>
              </a:prstGeom>
              <a:ln w="9525">
                <a:solidFill>
                  <a:schemeClr val="tx1">
                    <a:lumMod val="65000"/>
                    <a:lumOff val="3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24394EF5-D0D2-4774-A388-B5DD58DB49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09142844"/>
              </p:ext>
            </p:extLst>
          </p:nvPr>
        </p:nvGraphicFramePr>
        <p:xfrm>
          <a:off x="2099749" y="2106209"/>
          <a:ext cx="2658603" cy="2396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EDB2D33F-44AA-47FB-8B5A-6F7B35C81820}"/>
              </a:ext>
            </a:extLst>
          </p:cNvPr>
          <p:cNvGrpSpPr/>
          <p:nvPr/>
        </p:nvGrpSpPr>
        <p:grpSpPr>
          <a:xfrm>
            <a:off x="2915554" y="2524302"/>
            <a:ext cx="67735" cy="72000"/>
            <a:chOff x="5968999" y="1786467"/>
            <a:chExt cx="76200" cy="364066"/>
          </a:xfrm>
        </p:grpSpPr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74A7F194-98C1-483B-B0CA-7B26F1C4999A}"/>
                </a:ext>
              </a:extLst>
            </p:cNvPr>
            <p:cNvCxnSpPr/>
            <p:nvPr/>
          </p:nvCxnSpPr>
          <p:spPr>
            <a:xfrm>
              <a:off x="5968999" y="1786467"/>
              <a:ext cx="76200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0548BB34-2573-49F8-A622-9857F31C5FF2}"/>
                </a:ext>
              </a:extLst>
            </p:cNvPr>
            <p:cNvCxnSpPr/>
            <p:nvPr/>
          </p:nvCxnSpPr>
          <p:spPr>
            <a:xfrm>
              <a:off x="6002867" y="1786467"/>
              <a:ext cx="0" cy="364066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410BDD67-C32D-42CE-BE6A-B8A19AA16C7F}"/>
              </a:ext>
            </a:extLst>
          </p:cNvPr>
          <p:cNvGrpSpPr/>
          <p:nvPr/>
        </p:nvGrpSpPr>
        <p:grpSpPr>
          <a:xfrm>
            <a:off x="3438908" y="2548675"/>
            <a:ext cx="67735" cy="36000"/>
            <a:chOff x="5968999" y="1786467"/>
            <a:chExt cx="76200" cy="364066"/>
          </a:xfrm>
        </p:grpSpPr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D8A0EDAE-5C9F-417B-8062-0B646A74DA35}"/>
                </a:ext>
              </a:extLst>
            </p:cNvPr>
            <p:cNvCxnSpPr/>
            <p:nvPr/>
          </p:nvCxnSpPr>
          <p:spPr>
            <a:xfrm>
              <a:off x="5968999" y="1786467"/>
              <a:ext cx="76200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0446392D-CBEB-4A92-B4B2-99C46BC5288A}"/>
                </a:ext>
              </a:extLst>
            </p:cNvPr>
            <p:cNvCxnSpPr/>
            <p:nvPr/>
          </p:nvCxnSpPr>
          <p:spPr>
            <a:xfrm>
              <a:off x="6002867" y="1786467"/>
              <a:ext cx="0" cy="364066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C5968226-7854-47F6-819C-60471AEB12F3}"/>
              </a:ext>
            </a:extLst>
          </p:cNvPr>
          <p:cNvGrpSpPr/>
          <p:nvPr/>
        </p:nvGrpSpPr>
        <p:grpSpPr>
          <a:xfrm>
            <a:off x="3964895" y="2554037"/>
            <a:ext cx="67735" cy="18000"/>
            <a:chOff x="5968999" y="1786467"/>
            <a:chExt cx="76200" cy="364066"/>
          </a:xfrm>
        </p:grpSpPr>
        <p:cxnSp>
          <p:nvCxnSpPr>
            <p:cNvPr id="22" name="直線コネクタ 21">
              <a:extLst>
                <a:ext uri="{FF2B5EF4-FFF2-40B4-BE49-F238E27FC236}">
                  <a16:creationId xmlns:a16="http://schemas.microsoft.com/office/drawing/2014/main" id="{404F00E6-D702-49B9-A448-017438166EA3}"/>
                </a:ext>
              </a:extLst>
            </p:cNvPr>
            <p:cNvCxnSpPr/>
            <p:nvPr/>
          </p:nvCxnSpPr>
          <p:spPr>
            <a:xfrm>
              <a:off x="5968999" y="1786467"/>
              <a:ext cx="76200" cy="0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9D8172BB-EB05-40C5-95FE-FB4B90D92D09}"/>
                </a:ext>
              </a:extLst>
            </p:cNvPr>
            <p:cNvCxnSpPr/>
            <p:nvPr/>
          </p:nvCxnSpPr>
          <p:spPr>
            <a:xfrm>
              <a:off x="6002867" y="1786467"/>
              <a:ext cx="0" cy="364066"/>
            </a:xfrm>
            <a:prstGeom prst="line">
              <a:avLst/>
            </a:prstGeom>
            <a:ln w="952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91429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4633A65-E5EA-47B7-A35B-D3A6786EB8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673" y="3355377"/>
            <a:ext cx="6488654" cy="2433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8218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93</TotalTime>
  <Words>331</Words>
  <Application>Microsoft Office PowerPoint</Application>
  <PresentationFormat>画面に合わせる (4:3)</PresentationFormat>
  <Paragraphs>5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koto Kusaba</dc:creator>
  <cp:lastModifiedBy>信 草場</cp:lastModifiedBy>
  <cp:revision>381</cp:revision>
  <cp:lastPrinted>2025-01-20T23:29:20Z</cp:lastPrinted>
  <dcterms:created xsi:type="dcterms:W3CDTF">2024-06-27T06:45:45Z</dcterms:created>
  <dcterms:modified xsi:type="dcterms:W3CDTF">2025-04-20T00:04:11Z</dcterms:modified>
</cp:coreProperties>
</file>